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6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504"/>
          <a:stretch/>
        </p:blipFill>
        <p:spPr>
          <a:xfrm>
            <a:off x="1200522" y="407533"/>
            <a:ext cx="5603726" cy="20882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01547" y="2063919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st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73747" y="2060848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d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292142" y="2060848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784478" y="2060848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340446" y="2063919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08614" y="2060848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550232" y="2060848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024838" y="2276872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r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212654" y="2060848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562646" y="2063210"/>
            <a:ext cx="419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th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27584" y="1793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248227" y="5373216"/>
            <a:ext cx="83529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: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Diagram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notypin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usk traits. (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 husk number; (B) husk length; (C) husk width; (D) husk thickness.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C:\Users\admin\Desktop\BMC Genomics\husk length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0600" y="2708919"/>
            <a:ext cx="1613142" cy="20162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827584" y="24912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2823742" y="249122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pic>
        <p:nvPicPr>
          <p:cNvPr id="1027" name="Picture 3" descr="C:\Users\admin\Desktop\BMC Genomics\husk width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7197" y="2708920"/>
            <a:ext cx="1610827" cy="20162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admin\Desktop\BMC Genomics\husk thickness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056" y="2708920"/>
            <a:ext cx="1656184" cy="2016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4748722" y="249289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88672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1</Words>
  <Application>Microsoft Office PowerPoint</Application>
  <PresentationFormat>全屏显示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15</cp:revision>
  <dcterms:created xsi:type="dcterms:W3CDTF">2016-10-08T07:23:42Z</dcterms:created>
  <dcterms:modified xsi:type="dcterms:W3CDTF">2016-11-08T07:22:03Z</dcterms:modified>
</cp:coreProperties>
</file>